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87" r:id="rId2"/>
  </p:sldIdLst>
  <p:sldSz cx="6492875" cy="6218238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37" userDrawn="1">
          <p15:clr>
            <a:srgbClr val="A4A3A4"/>
          </p15:clr>
        </p15:guide>
        <p15:guide id="3" orient="horz" pos="375" userDrawn="1">
          <p15:clr>
            <a:srgbClr val="A4A3A4"/>
          </p15:clr>
        </p15:guide>
        <p15:guide id="4" pos="1349" userDrawn="1">
          <p15:clr>
            <a:srgbClr val="A4A3A4"/>
          </p15:clr>
        </p15:guide>
        <p15:guide id="5" orient="horz" pos="20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udhary, Ritu" initials="CR" lastIdx="1" clrIdx="0">
    <p:extLst>
      <p:ext uri="{19B8F6BF-5375-455C-9EA6-DF929625EA0E}">
        <p15:presenceInfo xmlns:p15="http://schemas.microsoft.com/office/powerpoint/2012/main" userId="S::Ritu.Chaudhary@moffitt.org::e213b328-12f3-42f9-9afb-2fdf354946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D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32" autoAdjust="0"/>
    <p:restoredTop sz="90099" autoAdjust="0"/>
  </p:normalViewPr>
  <p:slideViewPr>
    <p:cSldViewPr snapToGrid="0">
      <p:cViewPr varScale="1">
        <p:scale>
          <a:sx n="160" d="100"/>
          <a:sy n="160" d="100"/>
        </p:scale>
        <p:origin x="3736" y="84"/>
      </p:cViewPr>
      <p:guideLst>
        <p:guide pos="3437"/>
        <p:guide orient="horz" pos="375"/>
        <p:guide pos="1349"/>
        <p:guide orient="horz" pos="203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3D79D2C-534C-49B8-BF89-98F21FED85F5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1663" y="1163638"/>
            <a:ext cx="32797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FBF2B51-D0C1-4CC3-B696-54FB44FD7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84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76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52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628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504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79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255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131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3007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BF2B51-D0C1-4CC3-B696-54FB44FD7B1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7045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017661"/>
            <a:ext cx="5518944" cy="2164868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3266015"/>
            <a:ext cx="4869656" cy="1501301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5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331064"/>
            <a:ext cx="1400026" cy="5269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331064"/>
            <a:ext cx="4118918" cy="5269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61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1550243"/>
            <a:ext cx="5600105" cy="2586614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4161327"/>
            <a:ext cx="5600105" cy="136023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08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331065"/>
            <a:ext cx="5600105" cy="12019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1524332"/>
            <a:ext cx="2746790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2271384"/>
            <a:ext cx="2746790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1524332"/>
            <a:ext cx="2760318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2271384"/>
            <a:ext cx="2760318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3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895313"/>
            <a:ext cx="3287018" cy="4418979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8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895313"/>
            <a:ext cx="3287018" cy="4418979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331065"/>
            <a:ext cx="5600105" cy="12019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1655318"/>
            <a:ext cx="5600105" cy="39454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5763387"/>
            <a:ext cx="2191345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25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B49E948-ADB8-4B26-91FB-C99D1A9549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3609" y="359364"/>
            <a:ext cx="5005656" cy="51756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1FA7393-94EF-498F-A93B-C73F91366231}"/>
              </a:ext>
            </a:extLst>
          </p:cNvPr>
          <p:cNvSpPr txBox="1"/>
          <p:nvPr/>
        </p:nvSpPr>
        <p:spPr>
          <a:xfrm>
            <a:off x="4964707" y="-6680"/>
            <a:ext cx="1609950" cy="2484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0044126-0226-49DA-8A16-181EE23C2CAD}"/>
              </a:ext>
            </a:extLst>
          </p:cNvPr>
          <p:cNvSpPr txBox="1"/>
          <p:nvPr/>
        </p:nvSpPr>
        <p:spPr>
          <a:xfrm>
            <a:off x="211015" y="5460023"/>
            <a:ext cx="602273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5:  </a:t>
            </a:r>
            <a:endParaRPr lang="en-U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otein network analysis of core-enriched genes within the hypoxia signature and TGF-β signaling from GSEA analysis. Clustering was performed using the STRING database. Three main clusters are depicted: hypoxia (blue color), TGF-β (green color)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 EGFR (red color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endParaRPr lang="en-U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979064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714</TotalTime>
  <Words>55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udhary, Ritu</dc:creator>
  <cp:lastModifiedBy>Chung, Christine H</cp:lastModifiedBy>
  <cp:revision>383</cp:revision>
  <cp:lastPrinted>2022-01-03T15:25:01Z</cp:lastPrinted>
  <dcterms:created xsi:type="dcterms:W3CDTF">2021-01-11T21:01:01Z</dcterms:created>
  <dcterms:modified xsi:type="dcterms:W3CDTF">2023-04-30T13:05:58Z</dcterms:modified>
</cp:coreProperties>
</file>